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4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6" autoAdjust="0"/>
    <p:restoredTop sz="94660"/>
  </p:normalViewPr>
  <p:slideViewPr>
    <p:cSldViewPr snapToGrid="0">
      <p:cViewPr varScale="1">
        <p:scale>
          <a:sx n="42" d="100"/>
          <a:sy n="42" d="100"/>
        </p:scale>
        <p:origin x="2241" y="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DEAA6-28F3-4DAA-8ABD-16A1C12EE55E}" type="datetimeFigureOut">
              <a:rPr lang="zh-CN" altLang="en-US" smtClean="0"/>
              <a:t>2023/12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7D066D-A427-4890-A0E3-E38AE222C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386694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DEAA6-28F3-4DAA-8ABD-16A1C12EE55E}" type="datetimeFigureOut">
              <a:rPr lang="zh-CN" altLang="en-US" smtClean="0"/>
              <a:t>2023/12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7D066D-A427-4890-A0E3-E38AE222C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214776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DEAA6-28F3-4DAA-8ABD-16A1C12EE55E}" type="datetimeFigureOut">
              <a:rPr lang="zh-CN" altLang="en-US" smtClean="0"/>
              <a:t>2023/12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7D066D-A427-4890-A0E3-E38AE222C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20270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DEAA6-28F3-4DAA-8ABD-16A1C12EE55E}" type="datetimeFigureOut">
              <a:rPr lang="zh-CN" altLang="en-US" smtClean="0"/>
              <a:t>2023/12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7D066D-A427-4890-A0E3-E38AE222C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27748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DEAA6-28F3-4DAA-8ABD-16A1C12EE55E}" type="datetimeFigureOut">
              <a:rPr lang="zh-CN" altLang="en-US" smtClean="0"/>
              <a:t>2023/12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7D066D-A427-4890-A0E3-E38AE222C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104476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DEAA6-28F3-4DAA-8ABD-16A1C12EE55E}" type="datetimeFigureOut">
              <a:rPr lang="zh-CN" altLang="en-US" smtClean="0"/>
              <a:t>2023/12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7D066D-A427-4890-A0E3-E38AE222C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16804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DEAA6-28F3-4DAA-8ABD-16A1C12EE55E}" type="datetimeFigureOut">
              <a:rPr lang="zh-CN" altLang="en-US" smtClean="0"/>
              <a:t>2023/12/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7D066D-A427-4890-A0E3-E38AE222C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906128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DEAA6-28F3-4DAA-8ABD-16A1C12EE55E}" type="datetimeFigureOut">
              <a:rPr lang="zh-CN" altLang="en-US" smtClean="0"/>
              <a:t>2023/12/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7D066D-A427-4890-A0E3-E38AE222C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13990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DEAA6-28F3-4DAA-8ABD-16A1C12EE55E}" type="datetimeFigureOut">
              <a:rPr lang="zh-CN" altLang="en-US" smtClean="0"/>
              <a:t>2023/12/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7D066D-A427-4890-A0E3-E38AE222C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38877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DEAA6-28F3-4DAA-8ABD-16A1C12EE55E}" type="datetimeFigureOut">
              <a:rPr lang="zh-CN" altLang="en-US" smtClean="0"/>
              <a:t>2023/12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7D066D-A427-4890-A0E3-E38AE222C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759766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DEAA6-28F3-4DAA-8ABD-16A1C12EE55E}" type="datetimeFigureOut">
              <a:rPr lang="zh-CN" altLang="en-US" smtClean="0"/>
              <a:t>2023/12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7D066D-A427-4890-A0E3-E38AE222C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37997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0DEAA6-28F3-4DAA-8ABD-16A1C12EE55E}" type="datetimeFigureOut">
              <a:rPr lang="zh-CN" altLang="en-US" smtClean="0"/>
              <a:t>2023/12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7D066D-A427-4890-A0E3-E38AE222C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66567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6CC9B773-BD0B-8B63-1627-F27384E0ADC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822192" y="420965"/>
            <a:ext cx="2578607" cy="3006194"/>
          </a:xfrm>
          <a:prstGeom prst="rect">
            <a:avLst/>
          </a:prstGeom>
        </p:spPr>
      </p:pic>
      <p:pic>
        <p:nvPicPr>
          <p:cNvPr id="7" name="图片 6" descr="图片包含 照片, 游戏机, 动物&#10;&#10;描述已自动生成">
            <a:extLst>
              <a:ext uri="{FF2B5EF4-FFF2-40B4-BE49-F238E27FC236}">
                <a16:creationId xmlns:a16="http://schemas.microsoft.com/office/drawing/2014/main" id="{231B9D23-EEE5-6010-D666-532E5586A47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9000" y="420965"/>
            <a:ext cx="3240000" cy="3240000"/>
          </a:xfrm>
          <a:prstGeom prst="rect">
            <a:avLst/>
          </a:prstGeom>
        </p:spPr>
      </p:pic>
      <p:sp>
        <p:nvSpPr>
          <p:cNvPr id="8" name="文本框 4">
            <a:extLst>
              <a:ext uri="{FF2B5EF4-FFF2-40B4-BE49-F238E27FC236}">
                <a16:creationId xmlns:a16="http://schemas.microsoft.com/office/drawing/2014/main" id="{17FA79B4-1BA5-ECA7-5015-4B9D19BA1B06}"/>
              </a:ext>
            </a:extLst>
          </p:cNvPr>
          <p:cNvSpPr txBox="1"/>
          <p:nvPr/>
        </p:nvSpPr>
        <p:spPr>
          <a:xfrm>
            <a:off x="56248" y="138498"/>
            <a:ext cx="26550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7">
            <a:extLst>
              <a:ext uri="{FF2B5EF4-FFF2-40B4-BE49-F238E27FC236}">
                <a16:creationId xmlns:a16="http://schemas.microsoft.com/office/drawing/2014/main" id="{C656AB6B-C3C8-092C-CBD2-3BC204C48E75}"/>
              </a:ext>
            </a:extLst>
          </p:cNvPr>
          <p:cNvSpPr txBox="1"/>
          <p:nvPr/>
        </p:nvSpPr>
        <p:spPr>
          <a:xfrm>
            <a:off x="3879342" y="138499"/>
            <a:ext cx="26550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536E8DAE-A7CE-111C-25B5-25946CACCB24}"/>
              </a:ext>
            </a:extLst>
          </p:cNvPr>
          <p:cNvSpPr txBox="1"/>
          <p:nvPr/>
        </p:nvSpPr>
        <p:spPr>
          <a:xfrm>
            <a:off x="0" y="3786412"/>
            <a:ext cx="68580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S1. Patient information. (A)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Radiographs of different types of hip osteoarthritis (HOA).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Japanese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Orthopaedic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Association (JOA) hip score results of patients.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266845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846</TotalTime>
  <Words>37</Words>
  <Application>Microsoft Office PowerPoint</Application>
  <PresentationFormat>A4 纸张(210x297 毫米)</PresentationFormat>
  <Paragraphs>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ang Yang</dc:creator>
  <cp:lastModifiedBy>Yang Yang</cp:lastModifiedBy>
  <cp:revision>51</cp:revision>
  <dcterms:created xsi:type="dcterms:W3CDTF">2023-07-28T06:37:02Z</dcterms:created>
  <dcterms:modified xsi:type="dcterms:W3CDTF">2023-12-01T18:13:01Z</dcterms:modified>
</cp:coreProperties>
</file>